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57" r:id="rId4"/>
    <p:sldId id="259" r:id="rId5"/>
    <p:sldId id="265" r:id="rId6"/>
  </p:sldIdLst>
  <p:sldSz cx="12192000" cy="6858000"/>
  <p:notesSz cx="6858000" cy="9144000"/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7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557F8D-7283-4866-B947-0584FA2826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F60AF98-5DB7-4227-BBDC-05CDAB0E3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E5305B4-2830-495C-A862-3152B90A3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CC1925-8064-494A-97F4-27FECABA9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9F939B-9FF7-45B6-A403-916C039D0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77687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7AAD6D-7D9A-4F0F-A29C-7CF7B91BB9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60EC10-078C-4412-9E33-8DA92BD952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E59A38-DA24-49F1-8567-09E5CF8E4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336B42-71DE-4960-A2EB-906BEA06F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B5C463-F16E-45B1-9047-879633DBE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315320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CBAEC3F-395E-4946-B702-D54E91471C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4C2DD5B-6D08-431F-A71B-BEED12E8B1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89646B-28F5-40BF-B93D-9A994EC22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84220D-E60D-45D4-B6E6-6B72EE1D5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D4006E-E923-4C0D-8DE7-A36E0405D5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742350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0E21EA-75DC-4C95-9127-B757809F6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41E5CC-7CF6-4B4B-A017-D787453D3E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AA50BF-17D0-4383-8B61-D447FBF26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ABF6E-EA56-46AB-9F8C-DD9D1B900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C0DEB27-0F99-4C9D-BF94-84C1A1C12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356185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75CF2A-E0E9-4300-850D-0563C2FA9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4F0642-A923-4871-A80A-DC013ADE51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F2821B-2904-4690-99F2-08F4EDD1E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1BAA71-4F3D-4877-B79E-0C839E051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0D6831-8C91-4E23-A145-4AB37EEA3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200860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4B616A-A36C-4EB1-B609-C9E8FDB5C7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746A4D-BAF1-4DEB-8C04-BAD1A5F89A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A3945F8-7774-469D-AF03-B61BE4E8D3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1616A2-DE1B-4937-8E98-53A90E8BB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D3F761D-7762-4705-8D6E-7DAA05E46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3BCB097-CE9D-4BF4-8A9B-012FE10BE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778337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886F50-74D9-49CF-A73B-D758D84A28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23648A4-20D9-4AF2-AB2C-70EE1AC36A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B2C328D-C2AF-40FF-B8CB-8479242E83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8469D83-22B0-4625-A84F-5E6198194C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BD934A1-5E1C-4FB2-8F7B-0D709754C2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4758BD8-66C1-45B1-AFA2-DF4FFF914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5B2BEEA-CE01-439F-A229-68D4EC147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460CC43-5C75-4FFD-93FD-49B49D11D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87078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C278CD-DDD6-40FF-83DE-39362920E0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B9F08B1-4A5B-4CE1-B747-772F0A5D2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F1D07BA-83BC-4528-BD5B-944A74C4F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0946B6F-BCC4-4C12-A149-E29D9F0B4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05132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EBCB327-3A72-4047-9862-3C8826C3D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EBBD659-7D23-4C0C-85A2-CECD3E7B7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7BB406C-3A11-45CD-B85E-43C5A724F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58893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0CB1D7-CE67-4ED7-9C10-DFC1E7728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D526B9A-DEA7-4ED4-B885-22426A78F2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8EBDEA8-2470-49CA-A982-704F5BCF9A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1417D3-64FC-4BA4-8BF0-7C10CE34E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6DD5C1-EC37-4135-BB9E-B2E793FE8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688162F-4934-43D9-8865-E808F12739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06813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4B3EAE-6C28-44C5-A63A-CA63BF50B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4322020-8139-4788-80FB-4DE9EA283E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K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C02BBB8-C999-4BE8-A513-11E0AFB207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00F84C9-A176-43BA-B66F-158AC8025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AD4C719-F6EA-4DF3-BDDC-E3AE2E77E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BABD0C1-4914-4CB5-A33D-F7788C733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10700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1464D56-3B11-47A2-AB60-D5E2701BE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HK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7CC03C-547B-4A65-98FD-ACB78025F6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zh-HK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90EBED-42E1-4671-AA70-0407BB4558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63ABC-2A18-441A-A71C-AED5847E79B2}" type="datetimeFigureOut">
              <a:rPr lang="zh-HK" altLang="en-US" smtClean="0"/>
              <a:t>22/8/2020</a:t>
            </a:fld>
            <a:endParaRPr lang="zh-HK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1FF0DC-5A38-4D8A-8BC4-1A2D3B275D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94F486-D4CF-47AC-B481-94E37B1903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5068A-A8BE-446B-8DD0-2362EBF1B584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61655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tif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C0EB8F0A-E9CB-4F25-9559-D4EE6D68CF5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34" y="606425"/>
            <a:ext cx="8030942" cy="4351338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C93994D-67A0-4B3C-B155-E6858924CDD2}"/>
              </a:ext>
            </a:extLst>
          </p:cNvPr>
          <p:cNvSpPr txBox="1"/>
          <p:nvPr/>
        </p:nvSpPr>
        <p:spPr>
          <a:xfrm>
            <a:off x="3280418" y="1273653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AFAFB4B-A0CD-4933-8135-24B82A8A52D9}"/>
              </a:ext>
            </a:extLst>
          </p:cNvPr>
          <p:cNvSpPr txBox="1"/>
          <p:nvPr/>
        </p:nvSpPr>
        <p:spPr>
          <a:xfrm>
            <a:off x="2980057" y="570707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B00F02D-8840-4EA5-95BE-03E5E256064D}"/>
              </a:ext>
            </a:extLst>
          </p:cNvPr>
          <p:cNvSpPr txBox="1"/>
          <p:nvPr/>
        </p:nvSpPr>
        <p:spPr>
          <a:xfrm>
            <a:off x="2253567" y="1273653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7762AB3-12F0-40BC-82E4-F68B3C85FF77}"/>
              </a:ext>
            </a:extLst>
          </p:cNvPr>
          <p:cNvSpPr txBox="1"/>
          <p:nvPr/>
        </p:nvSpPr>
        <p:spPr>
          <a:xfrm>
            <a:off x="3872262" y="1633945"/>
            <a:ext cx="736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81DB2F0-2EEF-4AA4-80CC-65CB89D0F37B}"/>
              </a:ext>
            </a:extLst>
          </p:cNvPr>
          <p:cNvSpPr txBox="1"/>
          <p:nvPr/>
        </p:nvSpPr>
        <p:spPr>
          <a:xfrm>
            <a:off x="4487779" y="1607267"/>
            <a:ext cx="736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4988A4F-2870-489F-8FF3-2C7EFC252629}"/>
              </a:ext>
            </a:extLst>
          </p:cNvPr>
          <p:cNvSpPr txBox="1"/>
          <p:nvPr/>
        </p:nvSpPr>
        <p:spPr>
          <a:xfrm>
            <a:off x="1040406" y="949202"/>
            <a:ext cx="154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 err="1"/>
              <a:t>CaSR</a:t>
            </a:r>
            <a:endParaRPr lang="zh-HK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1A438BD-F098-46FD-9B3C-72A8D16D6556}"/>
              </a:ext>
            </a:extLst>
          </p:cNvPr>
          <p:cNvSpPr txBox="1"/>
          <p:nvPr/>
        </p:nvSpPr>
        <p:spPr>
          <a:xfrm>
            <a:off x="2990413" y="4315786"/>
            <a:ext cx="2234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Testicular tissue</a:t>
            </a:r>
            <a:endParaRPr lang="zh-HK" altLang="en-US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0BDBAB0A-0C95-4AE1-9899-463AD93676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73769" y="1642985"/>
            <a:ext cx="5218231" cy="1848018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10DDADE6-6801-4146-8773-B42D403AC279}"/>
              </a:ext>
            </a:extLst>
          </p:cNvPr>
          <p:cNvSpPr txBox="1"/>
          <p:nvPr/>
        </p:nvSpPr>
        <p:spPr>
          <a:xfrm>
            <a:off x="7165238" y="2065429"/>
            <a:ext cx="154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ACTIN</a:t>
            </a:r>
            <a:endParaRPr lang="zh-HK" altLang="en-US" dirty="0"/>
          </a:p>
        </p:txBody>
      </p:sp>
    </p:spTree>
    <p:extLst>
      <p:ext uri="{BB962C8B-B14F-4D97-AF65-F5344CB8AC3E}">
        <p14:creationId xmlns:p14="http://schemas.microsoft.com/office/powerpoint/2010/main" val="1506795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内容占位符 6">
            <a:extLst>
              <a:ext uri="{FF2B5EF4-FFF2-40B4-BE49-F238E27FC236}">
                <a16:creationId xmlns:a16="http://schemas.microsoft.com/office/drawing/2014/main" id="{25FB19BA-0AB6-4CDF-9501-0428C0D9682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89573" y="1491128"/>
            <a:ext cx="4039038" cy="3304949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1FDC0658-14D4-42ED-98EA-7BFF3D48C3FA}"/>
              </a:ext>
            </a:extLst>
          </p:cNvPr>
          <p:cNvSpPr txBox="1"/>
          <p:nvPr/>
        </p:nvSpPr>
        <p:spPr>
          <a:xfrm>
            <a:off x="3373016" y="2326500"/>
            <a:ext cx="1509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1DEB140-3840-43DB-9C6B-C6146A536907}"/>
              </a:ext>
            </a:extLst>
          </p:cNvPr>
          <p:cNvSpPr txBox="1"/>
          <p:nvPr/>
        </p:nvSpPr>
        <p:spPr>
          <a:xfrm>
            <a:off x="2463975" y="2326500"/>
            <a:ext cx="1251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B5C0EAF-62D6-42F0-A2D4-B916B718804F}"/>
              </a:ext>
            </a:extLst>
          </p:cNvPr>
          <p:cNvSpPr txBox="1"/>
          <p:nvPr/>
        </p:nvSpPr>
        <p:spPr>
          <a:xfrm>
            <a:off x="841280" y="1805937"/>
            <a:ext cx="154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 err="1"/>
              <a:t>CaSR</a:t>
            </a:r>
            <a:endParaRPr lang="zh-HK" altLang="en-US" dirty="0"/>
          </a:p>
        </p:txBody>
      </p:sp>
      <p:pic>
        <p:nvPicPr>
          <p:cNvPr id="12" name="内容占位符 3">
            <a:extLst>
              <a:ext uri="{FF2B5EF4-FFF2-40B4-BE49-F238E27FC236}">
                <a16:creationId xmlns:a16="http://schemas.microsoft.com/office/drawing/2014/main" id="{F0820B34-6D41-428A-AA73-FF6C3CB10B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13751" y="1950369"/>
            <a:ext cx="4046571" cy="265199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7CEE09A6-6C56-4379-84C2-97AF332C222C}"/>
              </a:ext>
            </a:extLst>
          </p:cNvPr>
          <p:cNvSpPr txBox="1"/>
          <p:nvPr/>
        </p:nvSpPr>
        <p:spPr>
          <a:xfrm>
            <a:off x="10370254" y="1950369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ACTIN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01D8B68-7F6E-4544-AA11-05D91B266B60}"/>
              </a:ext>
            </a:extLst>
          </p:cNvPr>
          <p:cNvSpPr txBox="1"/>
          <p:nvPr/>
        </p:nvSpPr>
        <p:spPr>
          <a:xfrm>
            <a:off x="7714454" y="2319701"/>
            <a:ext cx="1509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6FB1B50-28EB-4342-AB69-0345B8BD9986}"/>
              </a:ext>
            </a:extLst>
          </p:cNvPr>
          <p:cNvSpPr txBox="1"/>
          <p:nvPr/>
        </p:nvSpPr>
        <p:spPr>
          <a:xfrm>
            <a:off x="6935738" y="2343040"/>
            <a:ext cx="1251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B3213A0-C68A-4DD0-8AD7-86D8944BB8A8}"/>
              </a:ext>
            </a:extLst>
          </p:cNvPr>
          <p:cNvSpPr txBox="1"/>
          <p:nvPr/>
        </p:nvSpPr>
        <p:spPr>
          <a:xfrm>
            <a:off x="9376746" y="2343040"/>
            <a:ext cx="1509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92E64EC-73F4-4922-8663-19E38F34F11A}"/>
              </a:ext>
            </a:extLst>
          </p:cNvPr>
          <p:cNvSpPr txBox="1"/>
          <p:nvPr/>
        </p:nvSpPr>
        <p:spPr>
          <a:xfrm>
            <a:off x="8598030" y="2366379"/>
            <a:ext cx="1251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1A3DD2E-D277-43BB-947B-D44F7B3BE9E8}"/>
              </a:ext>
            </a:extLst>
          </p:cNvPr>
          <p:cNvSpPr txBox="1"/>
          <p:nvPr/>
        </p:nvSpPr>
        <p:spPr>
          <a:xfrm>
            <a:off x="4517493" y="5283149"/>
            <a:ext cx="2418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Testicular Macrophage</a:t>
            </a:r>
            <a:endParaRPr lang="zh-HK" altLang="en-US" dirty="0"/>
          </a:p>
        </p:txBody>
      </p:sp>
    </p:spTree>
    <p:extLst>
      <p:ext uri="{BB962C8B-B14F-4D97-AF65-F5344CB8AC3E}">
        <p14:creationId xmlns:p14="http://schemas.microsoft.com/office/powerpoint/2010/main" val="2817759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1C36109E-07C8-4846-9834-6D754A18D3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2515" y="1252645"/>
            <a:ext cx="2593710" cy="137171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E99DB44-6BB7-4E43-B62A-B2FD7B59C3C7}"/>
              </a:ext>
            </a:extLst>
          </p:cNvPr>
          <p:cNvSpPr txBox="1"/>
          <p:nvPr/>
        </p:nvSpPr>
        <p:spPr>
          <a:xfrm>
            <a:off x="572113" y="1569173"/>
            <a:ext cx="2454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ACTIN</a:t>
            </a:r>
            <a:endParaRPr lang="zh-HK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A348267-BD51-4773-8D73-E5F699C6AB0D}"/>
              </a:ext>
            </a:extLst>
          </p:cNvPr>
          <p:cNvSpPr txBox="1"/>
          <p:nvPr/>
        </p:nvSpPr>
        <p:spPr>
          <a:xfrm>
            <a:off x="5206641" y="1569173"/>
            <a:ext cx="2454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Caspase-1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09A0E40-61BF-49F8-859B-F90C5B50934A}"/>
              </a:ext>
            </a:extLst>
          </p:cNvPr>
          <p:cNvSpPr txBox="1"/>
          <p:nvPr/>
        </p:nvSpPr>
        <p:spPr>
          <a:xfrm>
            <a:off x="1652115" y="1217922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C4ED999-2B85-419D-A38D-16E93005336E}"/>
              </a:ext>
            </a:extLst>
          </p:cNvPr>
          <p:cNvSpPr txBox="1"/>
          <p:nvPr/>
        </p:nvSpPr>
        <p:spPr>
          <a:xfrm>
            <a:off x="2463501" y="1217922"/>
            <a:ext cx="736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493C8CF-DA03-4410-AC13-F73421FA8E51}"/>
              </a:ext>
            </a:extLst>
          </p:cNvPr>
          <p:cNvSpPr txBox="1"/>
          <p:nvPr/>
        </p:nvSpPr>
        <p:spPr>
          <a:xfrm>
            <a:off x="3131743" y="1222949"/>
            <a:ext cx="1715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+NPS2143</a:t>
            </a:r>
            <a:endParaRPr lang="zh-HK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1BF8958-A6D6-4D36-AECA-6C1102C60369}"/>
              </a:ext>
            </a:extLst>
          </p:cNvPr>
          <p:cNvSpPr txBox="1"/>
          <p:nvPr/>
        </p:nvSpPr>
        <p:spPr>
          <a:xfrm>
            <a:off x="6481707" y="835906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6BBBEB9-FD99-484E-9D52-F45CABFB01CC}"/>
              </a:ext>
            </a:extLst>
          </p:cNvPr>
          <p:cNvSpPr txBox="1"/>
          <p:nvPr/>
        </p:nvSpPr>
        <p:spPr>
          <a:xfrm>
            <a:off x="7293093" y="835906"/>
            <a:ext cx="736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510C374-2A0C-40D5-8D84-1E24BDFE7C9F}"/>
              </a:ext>
            </a:extLst>
          </p:cNvPr>
          <p:cNvSpPr txBox="1"/>
          <p:nvPr/>
        </p:nvSpPr>
        <p:spPr>
          <a:xfrm>
            <a:off x="7961335" y="840933"/>
            <a:ext cx="1715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+NPS2143</a:t>
            </a:r>
            <a:endParaRPr lang="zh-HK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D2E9871-7ACC-494A-9E10-4E4C439EA8C7}"/>
              </a:ext>
            </a:extLst>
          </p:cNvPr>
          <p:cNvSpPr txBox="1"/>
          <p:nvPr/>
        </p:nvSpPr>
        <p:spPr>
          <a:xfrm>
            <a:off x="3810550" y="5568298"/>
            <a:ext cx="2418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Testicular Macrophage</a:t>
            </a:r>
            <a:endParaRPr lang="zh-HK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C36B710-1EC4-4300-98AC-24F1ED690A73}"/>
              </a:ext>
            </a:extLst>
          </p:cNvPr>
          <p:cNvSpPr txBox="1"/>
          <p:nvPr/>
        </p:nvSpPr>
        <p:spPr>
          <a:xfrm>
            <a:off x="1258115" y="4112219"/>
            <a:ext cx="1762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NLRP3</a:t>
            </a:r>
            <a:endParaRPr lang="zh-HK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F2CD355-5E21-4366-BC15-927F0D62E1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5777" y="1234056"/>
            <a:ext cx="3769465" cy="2194944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8A50EE5B-5C42-498E-8707-47C2904598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7619" y="3931318"/>
            <a:ext cx="4958511" cy="1457736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2A139166-1586-4057-962F-7E41EAAE0FC0}"/>
              </a:ext>
            </a:extLst>
          </p:cNvPr>
          <p:cNvSpPr txBox="1"/>
          <p:nvPr/>
        </p:nvSpPr>
        <p:spPr>
          <a:xfrm>
            <a:off x="3727013" y="3933881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2130557-E095-4606-AD0B-3782CC49C149}"/>
              </a:ext>
            </a:extLst>
          </p:cNvPr>
          <p:cNvSpPr txBox="1"/>
          <p:nvPr/>
        </p:nvSpPr>
        <p:spPr>
          <a:xfrm>
            <a:off x="4538399" y="3933881"/>
            <a:ext cx="736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</a:t>
            </a:r>
            <a:endParaRPr lang="zh-HK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CFE6452-2343-4B59-A1D7-77A5DAECC531}"/>
              </a:ext>
            </a:extLst>
          </p:cNvPr>
          <p:cNvSpPr txBox="1"/>
          <p:nvPr/>
        </p:nvSpPr>
        <p:spPr>
          <a:xfrm>
            <a:off x="5206641" y="3938908"/>
            <a:ext cx="1715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UPEC+NPS2143</a:t>
            </a:r>
            <a:endParaRPr lang="zh-HK" altLang="en-US" dirty="0"/>
          </a:p>
        </p:txBody>
      </p:sp>
    </p:spTree>
    <p:extLst>
      <p:ext uri="{BB962C8B-B14F-4D97-AF65-F5344CB8AC3E}">
        <p14:creationId xmlns:p14="http://schemas.microsoft.com/office/powerpoint/2010/main" val="19410802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72F77A1-C993-4F44-AB02-8F36E8043C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0030" y="403354"/>
            <a:ext cx="9339631" cy="234595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1B01D80-85C3-4230-9FE4-12B60557A7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619" y="3447595"/>
            <a:ext cx="8881742" cy="266303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439CCCA-A548-496C-A740-3FEBA2C59000}"/>
              </a:ext>
            </a:extLst>
          </p:cNvPr>
          <p:cNvSpPr txBox="1"/>
          <p:nvPr/>
        </p:nvSpPr>
        <p:spPr>
          <a:xfrm>
            <a:off x="1652204" y="705035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A8B9A98-52DB-44C8-8E6B-0CA6563CD0F1}"/>
              </a:ext>
            </a:extLst>
          </p:cNvPr>
          <p:cNvSpPr txBox="1"/>
          <p:nvPr/>
        </p:nvSpPr>
        <p:spPr>
          <a:xfrm>
            <a:off x="2694291" y="705035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C1A9A64-910E-456B-9BA0-E2E14BE7207C}"/>
              </a:ext>
            </a:extLst>
          </p:cNvPr>
          <p:cNvSpPr txBox="1"/>
          <p:nvPr/>
        </p:nvSpPr>
        <p:spPr>
          <a:xfrm>
            <a:off x="3736378" y="705035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5D52151-AD15-4C6F-BE16-89953A27F639}"/>
              </a:ext>
            </a:extLst>
          </p:cNvPr>
          <p:cNvSpPr txBox="1"/>
          <p:nvPr/>
        </p:nvSpPr>
        <p:spPr>
          <a:xfrm>
            <a:off x="4778465" y="705035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D476A8B-D3D0-448B-A199-BAA4252959B4}"/>
              </a:ext>
            </a:extLst>
          </p:cNvPr>
          <p:cNvSpPr txBox="1"/>
          <p:nvPr/>
        </p:nvSpPr>
        <p:spPr>
          <a:xfrm>
            <a:off x="6142348" y="705035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6F23F6-4803-4775-B37B-152A7F638613}"/>
              </a:ext>
            </a:extLst>
          </p:cNvPr>
          <p:cNvSpPr txBox="1"/>
          <p:nvPr/>
        </p:nvSpPr>
        <p:spPr>
          <a:xfrm>
            <a:off x="5210071" y="335703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C6A8752-15DB-46EE-89FC-46C1B6B70045}"/>
              </a:ext>
            </a:extLst>
          </p:cNvPr>
          <p:cNvSpPr txBox="1"/>
          <p:nvPr/>
        </p:nvSpPr>
        <p:spPr>
          <a:xfrm>
            <a:off x="7995677" y="335703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2E56874-8572-4499-A5F8-F7542816C752}"/>
              </a:ext>
            </a:extLst>
          </p:cNvPr>
          <p:cNvSpPr txBox="1"/>
          <p:nvPr/>
        </p:nvSpPr>
        <p:spPr>
          <a:xfrm>
            <a:off x="7995677" y="2505670"/>
            <a:ext cx="26608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The end is affected by electrophoresis or membrane transfer</a:t>
            </a:r>
            <a:endParaRPr lang="zh-HK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0CA9CB6-3E99-45F5-BE08-0F7DA5B1D39C}"/>
              </a:ext>
            </a:extLst>
          </p:cNvPr>
          <p:cNvSpPr txBox="1"/>
          <p:nvPr/>
        </p:nvSpPr>
        <p:spPr>
          <a:xfrm>
            <a:off x="5140490" y="6399375"/>
            <a:ext cx="1669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TM3</a:t>
            </a:r>
            <a:endParaRPr lang="zh-HK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1960096-52FE-44F0-92BE-116C3EE5277B}"/>
              </a:ext>
            </a:extLst>
          </p:cNvPr>
          <p:cNvSpPr txBox="1"/>
          <p:nvPr/>
        </p:nvSpPr>
        <p:spPr>
          <a:xfrm>
            <a:off x="383579" y="594768"/>
            <a:ext cx="154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 err="1"/>
              <a:t>CaSR</a:t>
            </a:r>
            <a:endParaRPr lang="zh-HK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F7B1D60-D690-4C5A-BFB1-84D1481D02BF}"/>
              </a:ext>
            </a:extLst>
          </p:cNvPr>
          <p:cNvSpPr txBox="1"/>
          <p:nvPr/>
        </p:nvSpPr>
        <p:spPr>
          <a:xfrm>
            <a:off x="357832" y="4594446"/>
            <a:ext cx="154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ACTIN</a:t>
            </a:r>
            <a:endParaRPr lang="zh-HK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C826381-8F59-4028-844D-1E2A86D0B425}"/>
              </a:ext>
            </a:extLst>
          </p:cNvPr>
          <p:cNvSpPr txBox="1"/>
          <p:nvPr/>
        </p:nvSpPr>
        <p:spPr>
          <a:xfrm>
            <a:off x="1222478" y="3931823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6A3F261-D763-45C6-B653-2E4769AFC60E}"/>
              </a:ext>
            </a:extLst>
          </p:cNvPr>
          <p:cNvSpPr txBox="1"/>
          <p:nvPr/>
        </p:nvSpPr>
        <p:spPr>
          <a:xfrm>
            <a:off x="2094237" y="3950673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3E86DC6-20DE-499B-9E15-8AB90B0FEEC5}"/>
              </a:ext>
            </a:extLst>
          </p:cNvPr>
          <p:cNvSpPr txBox="1"/>
          <p:nvPr/>
        </p:nvSpPr>
        <p:spPr>
          <a:xfrm>
            <a:off x="2993214" y="3969523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742ADB3-8B0B-471A-A90E-854AA65CF251}"/>
              </a:ext>
            </a:extLst>
          </p:cNvPr>
          <p:cNvSpPr txBox="1"/>
          <p:nvPr/>
        </p:nvSpPr>
        <p:spPr>
          <a:xfrm>
            <a:off x="3853528" y="3950673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5ECFD2E-92E8-4CE2-8ECF-45EAC58FDE4D}"/>
              </a:ext>
            </a:extLst>
          </p:cNvPr>
          <p:cNvSpPr txBox="1"/>
          <p:nvPr/>
        </p:nvSpPr>
        <p:spPr>
          <a:xfrm>
            <a:off x="5893296" y="4191711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093A229-20A9-4F63-AAF7-D38A5EE65C00}"/>
              </a:ext>
            </a:extLst>
          </p:cNvPr>
          <p:cNvSpPr txBox="1"/>
          <p:nvPr/>
        </p:nvSpPr>
        <p:spPr>
          <a:xfrm>
            <a:off x="4414577" y="5184021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4A8EBB0-5538-4A61-818D-69F63240881F}"/>
              </a:ext>
            </a:extLst>
          </p:cNvPr>
          <p:cNvSpPr txBox="1"/>
          <p:nvPr/>
        </p:nvSpPr>
        <p:spPr>
          <a:xfrm>
            <a:off x="7903779" y="4195914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B9B0F6A-51F2-4366-A1AD-C5D525AEEEF7}"/>
              </a:ext>
            </a:extLst>
          </p:cNvPr>
          <p:cNvSpPr txBox="1"/>
          <p:nvPr/>
        </p:nvSpPr>
        <p:spPr>
          <a:xfrm>
            <a:off x="6467079" y="5184021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EE99DF8-88E5-4030-953D-2BC1298A7947}"/>
              </a:ext>
            </a:extLst>
          </p:cNvPr>
          <p:cNvSpPr txBox="1"/>
          <p:nvPr/>
        </p:nvSpPr>
        <p:spPr>
          <a:xfrm>
            <a:off x="8661063" y="724494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</p:spTree>
    <p:extLst>
      <p:ext uri="{BB962C8B-B14F-4D97-AF65-F5344CB8AC3E}">
        <p14:creationId xmlns:p14="http://schemas.microsoft.com/office/powerpoint/2010/main" val="14067935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F8AE1D41-0E05-4A66-BF96-66FD92314C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151" y="1598629"/>
            <a:ext cx="6344423" cy="2053812"/>
          </a:xfr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92CC6AA-3FE2-4E3B-AE81-9741281D7DA0}"/>
              </a:ext>
            </a:extLst>
          </p:cNvPr>
          <p:cNvSpPr txBox="1"/>
          <p:nvPr/>
        </p:nvSpPr>
        <p:spPr>
          <a:xfrm>
            <a:off x="2531896" y="839144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6F35BFA-D632-4EB3-96B5-669DD3F99D36}"/>
              </a:ext>
            </a:extLst>
          </p:cNvPr>
          <p:cNvSpPr txBox="1"/>
          <p:nvPr/>
        </p:nvSpPr>
        <p:spPr>
          <a:xfrm>
            <a:off x="3392210" y="820294"/>
            <a:ext cx="1473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HK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D3F1CA5-4ECE-43FC-A9F0-0A531DF7B53C}"/>
              </a:ext>
            </a:extLst>
          </p:cNvPr>
          <p:cNvSpPr txBox="1"/>
          <p:nvPr/>
        </p:nvSpPr>
        <p:spPr>
          <a:xfrm>
            <a:off x="3530041" y="1298951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6E963C6-B24D-41F9-B389-FB1B320FE6F4}"/>
              </a:ext>
            </a:extLst>
          </p:cNvPr>
          <p:cNvSpPr txBox="1"/>
          <p:nvPr/>
        </p:nvSpPr>
        <p:spPr>
          <a:xfrm>
            <a:off x="4699261" y="990802"/>
            <a:ext cx="2193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PK2 Overexpression </a:t>
            </a:r>
            <a:endParaRPr lang="zh-HK" altLang="en-US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20EDB180-442E-4D9A-AA92-F1F0A73F39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3245" y="1820120"/>
            <a:ext cx="4206605" cy="160795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949CD2D-C6AD-4607-ABA9-7855287B61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26217" y="4629093"/>
            <a:ext cx="3940659" cy="165368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03444467-DC46-4EEB-A522-E558B65A782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829" y="3888065"/>
            <a:ext cx="6344423" cy="26033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2791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81</Words>
  <Application>Microsoft Office PowerPoint</Application>
  <PresentationFormat>宽屏</PresentationFormat>
  <Paragraphs>5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磊 方</dc:creator>
  <cp:lastModifiedBy>磊 方</cp:lastModifiedBy>
  <cp:revision>23</cp:revision>
  <dcterms:created xsi:type="dcterms:W3CDTF">2020-04-26T12:42:25Z</dcterms:created>
  <dcterms:modified xsi:type="dcterms:W3CDTF">2020-08-22T12:31:36Z</dcterms:modified>
</cp:coreProperties>
</file>